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8" autoAdjust="0"/>
    <p:restoredTop sz="94660"/>
  </p:normalViewPr>
  <p:slideViewPr>
    <p:cSldViewPr snapToGrid="0">
      <p:cViewPr varScale="1">
        <p:scale>
          <a:sx n="94" d="100"/>
          <a:sy n="94" d="100"/>
        </p:scale>
        <p:origin x="7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C89B42-E9E6-4CF8-A8CF-D96555EC31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5A5513-9BFF-4063-8E3D-03C1E115DF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CC22A-25E3-4AC1-848C-0E2C1D19B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032C6F-693C-4974-AB98-B8D81FA83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19D8F7-7F33-4137-90B1-DCD4567CC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24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55ADB9-0B75-46CF-B146-02D984EA82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38987-8F60-449A-B60D-97D6006E57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55A51-2873-470F-99BE-127F21417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BBC5A7-CE96-4242-B49C-00638C92C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57CC39-C142-4AAF-84E2-824778921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090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645230-C4BC-4342-ADF9-EDE5F35490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7C2EAC-5CFC-4BD8-936C-9257C6EB20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1ADDF5-9246-4680-823D-42B063E5F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3ADAC8-A5AA-4D72-BA7B-AFE56A083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65EF36-9373-4486-A537-9C245053CC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60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7ADB1A-E5D4-4F4B-A73C-360678E8A7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D65FC0-E8AE-40BE-B052-EE9BDA2E02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EADF8A-DD2F-46CA-9A44-877CA2B8A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EA40B-83F1-4AC1-A9F3-086B233E7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37684C-3EBD-4285-8C3E-30CA18AC4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121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819F5-DEB1-4DE4-BF25-7114F1529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5453A9-35BA-47EB-AA93-4A86A9C275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668C20-4D79-4B3E-914F-769570025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9B1A50-3F6C-4688-BF46-5725A3912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DB6E77-1991-4A05-BBE7-A17101B40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604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0EC1D-1128-4000-9EDF-F3306FC16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E199D8-1F5B-4989-9F32-41A9643704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BEF69B-0F3A-4D45-BE6A-992EF7EE0F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995568-B57A-4F70-B9CE-9590AABF3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D82090-BAAC-490B-BEAD-1C802A3F2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1762AF-79AD-4A95-9E80-C8AFA8A40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948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FE2FE-1B2B-48C8-A41C-0AE4CD8D3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D05D14-0509-4A35-9871-6CCE1C9D57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1E48F3-BA89-4710-8794-4723E64711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BBFBD5-0D92-4E98-9B41-C36EA77037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8DAD3F-24CA-4B6F-9E83-09A56A3E1D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182E85-D9A8-4CD9-AFF1-15A1A66D9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11D375-4ADA-4926-8669-D8AADCBB2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CAFEE2-1134-439B-B118-7AD3CCBF0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3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1F645-35BE-4202-9862-D1B0F373A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C91EF5-C0A2-4164-AADE-B29452217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3D50A0-E9E8-4887-9E2F-5A3CE05FB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2F77FF0-E7AD-473A-AAED-6CE873A09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095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E14677-E016-4684-8264-FA1D431C3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C31C234-BD27-4D85-A712-D20CA10A7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F9E608-53E5-474D-8DB2-40DA8AA80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991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3461CA-F24E-4863-830E-BD4F1D76D5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8375CC-B540-48C6-9D04-FE44369CBA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9A5D4C-DBC6-45D7-818A-C92AE47F60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D47259-16C8-4EB8-AAB5-7EFDEFE0B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6D364E-CF7A-40C5-9DC5-5AF6D2B31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D773BB-F7A4-428C-8BD2-630ECEBA9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88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C84B1-593B-4DB5-81AA-A5A83D4E8D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B8FAB5-FDF7-4DF5-822B-B04B6E87C7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64A88B-2DDA-4986-9918-87E08EAC0F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8E5DAF-754D-4BCB-ABD9-D275EB0ED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5D1FFF-5A7F-4C76-8EB1-3E3EE190D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B38721-11AE-4576-880F-91C10B869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49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F3D04B-912F-47DD-94C0-4C5FE76F0D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0989FD-41F0-4251-BD42-34CA23CE2C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E5870-EDE7-4B3B-A4E5-B2C9391C8A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EEF89-9AB5-4265-8471-54773D522105}" type="datetimeFigureOut">
              <a:rPr lang="en-US" smtClean="0"/>
              <a:t>3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4C1D4-0925-407D-959E-26C5DF0BB0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77C8E-B9C7-4D20-B850-77F0A1CA16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9982B2-9DC0-435C-B4C2-C083500C4D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342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microsoft.com/office/2007/relationships/hdphoto" Target="../media/hdphoto2.wdp"/><Relationship Id="rId7" Type="http://schemas.openxmlformats.org/officeDocument/2006/relationships/image" Target="../media/image6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F987BE9-1AB8-4895-BD9C-FD5BA320D883}"/>
              </a:ext>
            </a:extLst>
          </p:cNvPr>
          <p:cNvSpPr txBox="1"/>
          <p:nvPr/>
        </p:nvSpPr>
        <p:spPr>
          <a:xfrm>
            <a:off x="375920" y="209927"/>
            <a:ext cx="4112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 G. Cleaved Caspase 3 and GAPDH</a:t>
            </a:r>
          </a:p>
        </p:txBody>
      </p:sp>
      <p:pic>
        <p:nvPicPr>
          <p:cNvPr id="6" name="Picture 5" descr="Graphical user interface, diagram&#10;&#10;Description automatically generated">
            <a:extLst>
              <a:ext uri="{FF2B5EF4-FFF2-40B4-BE49-F238E27FC236}">
                <a16:creationId xmlns:a16="http://schemas.microsoft.com/office/drawing/2014/main" id="{A0BAE9F9-37CE-4728-BBD4-90973A6CD5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28" t="7437" r="57241" b="78831"/>
          <a:stretch/>
        </p:blipFill>
        <p:spPr>
          <a:xfrm>
            <a:off x="2106590" y="739894"/>
            <a:ext cx="6238651" cy="3147814"/>
          </a:xfrm>
          <a:prstGeom prst="rect">
            <a:avLst/>
          </a:prstGeom>
        </p:spPr>
      </p:pic>
      <p:pic>
        <p:nvPicPr>
          <p:cNvPr id="7" name="Picture 6" descr="Graphical user interface, diagram&#10;&#10;Description automatically generated">
            <a:extLst>
              <a:ext uri="{FF2B5EF4-FFF2-40B4-BE49-F238E27FC236}">
                <a16:creationId xmlns:a16="http://schemas.microsoft.com/office/drawing/2014/main" id="{022ECAC0-90D3-41BD-8102-BC4C957C5DD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607" t="75226" r="14552" b="15331"/>
          <a:stretch/>
        </p:blipFill>
        <p:spPr>
          <a:xfrm>
            <a:off x="2336800" y="3887708"/>
            <a:ext cx="5923279" cy="234213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1C1D9CE-EF4A-4413-9232-D7831BB2890E}"/>
              </a:ext>
            </a:extLst>
          </p:cNvPr>
          <p:cNvSpPr txBox="1"/>
          <p:nvPr/>
        </p:nvSpPr>
        <p:spPr>
          <a:xfrm>
            <a:off x="8260079" y="2113280"/>
            <a:ext cx="1620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tal Caspase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BE1412-D335-454F-B3F9-8D3BF581926A}"/>
              </a:ext>
            </a:extLst>
          </p:cNvPr>
          <p:cNvSpPr txBox="1"/>
          <p:nvPr/>
        </p:nvSpPr>
        <p:spPr>
          <a:xfrm>
            <a:off x="8260079" y="2827774"/>
            <a:ext cx="1906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eaved Caspase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40BFB1-3DC9-4557-AF5F-6B56B3B465E7}"/>
              </a:ext>
            </a:extLst>
          </p:cNvPr>
          <p:cNvSpPr txBox="1"/>
          <p:nvPr/>
        </p:nvSpPr>
        <p:spPr>
          <a:xfrm>
            <a:off x="8260079" y="479552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2184729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2D95A9-CDDA-4DB6-88FB-0AABA5CEE487}"/>
              </a:ext>
            </a:extLst>
          </p:cNvPr>
          <p:cNvSpPr txBox="1"/>
          <p:nvPr/>
        </p:nvSpPr>
        <p:spPr>
          <a:xfrm>
            <a:off x="325120" y="538480"/>
            <a:ext cx="4112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 H. Cleaved Caspase 3 and GAPD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74B8B3-6F8B-47D3-837C-F6112E062D49}"/>
              </a:ext>
            </a:extLst>
          </p:cNvPr>
          <p:cNvSpPr txBox="1"/>
          <p:nvPr/>
        </p:nvSpPr>
        <p:spPr>
          <a:xfrm>
            <a:off x="1527111" y="4891832"/>
            <a:ext cx="31657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on   Iron   Mn  I+ Mn</a:t>
            </a:r>
          </a:p>
        </p:txBody>
      </p:sp>
      <p:pic>
        <p:nvPicPr>
          <p:cNvPr id="8" name="그림 10">
            <a:extLst>
              <a:ext uri="{FF2B5EF4-FFF2-40B4-BE49-F238E27FC236}">
                <a16:creationId xmlns:a16="http://schemas.microsoft.com/office/drawing/2014/main" id="{B8FD39CE-4C48-4FC2-AEF5-A88F0FAC1F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80" t="14195" r="52692" b="77017"/>
          <a:stretch/>
        </p:blipFill>
        <p:spPr>
          <a:xfrm>
            <a:off x="956688" y="1588873"/>
            <a:ext cx="6482082" cy="1840127"/>
          </a:xfrm>
          <a:prstGeom prst="rect">
            <a:avLst/>
          </a:prstGeom>
        </p:spPr>
      </p:pic>
      <p:pic>
        <p:nvPicPr>
          <p:cNvPr id="9" name="그림 27">
            <a:extLst>
              <a:ext uri="{FF2B5EF4-FFF2-40B4-BE49-F238E27FC236}">
                <a16:creationId xmlns:a16="http://schemas.microsoft.com/office/drawing/2014/main" id="{68980018-54C2-4F15-9A72-166CC2161D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160" t="58085" r="4697" b="36085"/>
          <a:stretch/>
        </p:blipFill>
        <p:spPr>
          <a:xfrm>
            <a:off x="1046480" y="3200400"/>
            <a:ext cx="6228080" cy="1183575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23EB93BF-EBE6-4964-A536-D85D18CD4619}"/>
              </a:ext>
            </a:extLst>
          </p:cNvPr>
          <p:cNvSpPr/>
          <p:nvPr/>
        </p:nvSpPr>
        <p:spPr>
          <a:xfrm>
            <a:off x="1371600" y="1278527"/>
            <a:ext cx="2082800" cy="35052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01F4F86-9F67-49FE-A20D-0B7F8C5579C9}"/>
              </a:ext>
            </a:extLst>
          </p:cNvPr>
          <p:cNvSpPr txBox="1"/>
          <p:nvPr/>
        </p:nvSpPr>
        <p:spPr>
          <a:xfrm>
            <a:off x="7371118" y="1952161"/>
            <a:ext cx="1620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tal Caspase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4E2A405-725C-4FC5-861F-D2D6E283518C}"/>
              </a:ext>
            </a:extLst>
          </p:cNvPr>
          <p:cNvSpPr txBox="1"/>
          <p:nvPr/>
        </p:nvSpPr>
        <p:spPr>
          <a:xfrm>
            <a:off x="7371118" y="2684780"/>
            <a:ext cx="1906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eaved Caspase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53BA5BD-E508-45EA-89E6-6B87A9AD0FFF}"/>
              </a:ext>
            </a:extLst>
          </p:cNvPr>
          <p:cNvSpPr txBox="1"/>
          <p:nvPr/>
        </p:nvSpPr>
        <p:spPr>
          <a:xfrm>
            <a:off x="7162802" y="364867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3476740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22A83AA-FD7B-4326-AD72-4112E332205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114" t="-8860" r="-8991" b="-47737"/>
          <a:stretch/>
        </p:blipFill>
        <p:spPr>
          <a:xfrm>
            <a:off x="553365" y="1562788"/>
            <a:ext cx="5496559" cy="26532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8ACB632-61A1-4BAB-A68B-BEAD96F246E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396" t="-13728" r="-7681" b="-43621"/>
          <a:stretch/>
        </p:blipFill>
        <p:spPr>
          <a:xfrm>
            <a:off x="904240" y="3029998"/>
            <a:ext cx="4984295" cy="1189249"/>
          </a:xfrm>
          <a:prstGeom prst="rect">
            <a:avLst/>
          </a:prstGeom>
        </p:spPr>
      </p:pic>
      <p:pic>
        <p:nvPicPr>
          <p:cNvPr id="9" name="Picture 8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B2A41DF7-FF87-4CDE-876A-F5EA628F14D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99" t="22084" r="61302" b="66313"/>
          <a:stretch/>
        </p:blipFill>
        <p:spPr>
          <a:xfrm>
            <a:off x="6096000" y="1266593"/>
            <a:ext cx="4619575" cy="1976205"/>
          </a:xfrm>
          <a:prstGeom prst="rect">
            <a:avLst/>
          </a:prstGeom>
        </p:spPr>
      </p:pic>
      <p:pic>
        <p:nvPicPr>
          <p:cNvPr id="17" name="Picture 16" descr="Graphical user interface&#10;&#10;Description automatically generated">
            <a:extLst>
              <a:ext uri="{FF2B5EF4-FFF2-40B4-BE49-F238E27FC236}">
                <a16:creationId xmlns:a16="http://schemas.microsoft.com/office/drawing/2014/main" id="{131D81C3-7130-46FC-A1DA-3BCA9DC6634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429" t="42427" r="12986" b="54872"/>
          <a:stretch/>
        </p:blipFill>
        <p:spPr>
          <a:xfrm>
            <a:off x="6239410" y="3529973"/>
            <a:ext cx="4117231" cy="59794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42620BD-A4F4-4B1C-9AA5-A1417CEB5436}"/>
              </a:ext>
            </a:extLst>
          </p:cNvPr>
          <p:cNvSpPr txBox="1"/>
          <p:nvPr/>
        </p:nvSpPr>
        <p:spPr>
          <a:xfrm>
            <a:off x="325120" y="538480"/>
            <a:ext cx="3289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 C. LC3B, P62 and GAPD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8E17FB8-DEC7-409F-BA20-C1E6A3C0217A}"/>
              </a:ext>
            </a:extLst>
          </p:cNvPr>
          <p:cNvSpPr txBox="1"/>
          <p:nvPr/>
        </p:nvSpPr>
        <p:spPr>
          <a:xfrm>
            <a:off x="5252720" y="2114788"/>
            <a:ext cx="6358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C3I</a:t>
            </a:r>
          </a:p>
          <a:p>
            <a:r>
              <a:rPr lang="en-US" dirty="0"/>
              <a:t>LC3II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8CB1782-9012-4AA9-8663-6218B9E4253C}"/>
              </a:ext>
            </a:extLst>
          </p:cNvPr>
          <p:cNvSpPr txBox="1"/>
          <p:nvPr/>
        </p:nvSpPr>
        <p:spPr>
          <a:xfrm>
            <a:off x="5336877" y="324433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6DA7312-6E49-4814-8A09-CFD826ACB84B}"/>
              </a:ext>
            </a:extLst>
          </p:cNvPr>
          <p:cNvSpPr txBox="1"/>
          <p:nvPr/>
        </p:nvSpPr>
        <p:spPr>
          <a:xfrm>
            <a:off x="11101308" y="1919962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6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F624FA2-43D2-4640-91B4-F1AE4BB69628}"/>
              </a:ext>
            </a:extLst>
          </p:cNvPr>
          <p:cNvSpPr txBox="1"/>
          <p:nvPr/>
        </p:nvSpPr>
        <p:spPr>
          <a:xfrm>
            <a:off x="10641567" y="375858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6C2C3437-E331-4515-8EC9-AF732C988E0F}"/>
              </a:ext>
            </a:extLst>
          </p:cNvPr>
          <p:cNvCxnSpPr>
            <a:cxnSpLocks/>
            <a:stCxn id="21" idx="1"/>
          </p:cNvCxnSpPr>
          <p:nvPr/>
        </p:nvCxnSpPr>
        <p:spPr>
          <a:xfrm flipH="1" flipV="1">
            <a:off x="10322801" y="2102395"/>
            <a:ext cx="778507" cy="2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17231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9</TotalTime>
  <Words>52</Words>
  <Application>Microsoft Office PowerPoint</Application>
  <PresentationFormat>Widescreen</PresentationFormat>
  <Paragraphs>1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yekyoung Sung</dc:creator>
  <cp:lastModifiedBy>Hyekyoung Sung</cp:lastModifiedBy>
  <cp:revision>5</cp:revision>
  <dcterms:created xsi:type="dcterms:W3CDTF">2022-03-03T20:42:43Z</dcterms:created>
  <dcterms:modified xsi:type="dcterms:W3CDTF">2022-03-18T19:08:16Z</dcterms:modified>
</cp:coreProperties>
</file>